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4"/>
  </p:sldMasterIdLst>
  <p:sldIdLst>
    <p:sldId id="261" r:id="rId5"/>
    <p:sldId id="270" r:id="rId6"/>
    <p:sldId id="269" r:id="rId7"/>
    <p:sldId id="271" r:id="rId8"/>
  </p:sldIdLst>
  <p:sldSz cx="6858000" cy="9906000" type="A4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1" autoAdjust="0"/>
    <p:restoredTop sz="94660"/>
  </p:normalViewPr>
  <p:slideViewPr>
    <p:cSldViewPr snapToGrid="0">
      <p:cViewPr>
        <p:scale>
          <a:sx n="70" d="100"/>
          <a:sy n="70" d="100"/>
        </p:scale>
        <p:origin x="1628" y="-10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5A0A3-A168-4BED-82E1-803CFD8159EB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60015-F781-4B9D-A00B-AB83E14FA8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6882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5A0A3-A168-4BED-82E1-803CFD8159EB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60015-F781-4B9D-A00B-AB83E14FA8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76466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5A0A3-A168-4BED-82E1-803CFD8159EB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60015-F781-4B9D-A00B-AB83E14FA8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1429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5A0A3-A168-4BED-82E1-803CFD8159EB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60015-F781-4B9D-A00B-AB83E14FA8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47002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5A0A3-A168-4BED-82E1-803CFD8159EB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60015-F781-4B9D-A00B-AB83E14FA8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08650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5A0A3-A168-4BED-82E1-803CFD8159EB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60015-F781-4B9D-A00B-AB83E14FA8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06250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5A0A3-A168-4BED-82E1-803CFD8159EB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60015-F781-4B9D-A00B-AB83E14FA8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8092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5A0A3-A168-4BED-82E1-803CFD8159EB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60015-F781-4B9D-A00B-AB83E14FA8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31142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5A0A3-A168-4BED-82E1-803CFD8159EB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60015-F781-4B9D-A00B-AB83E14FA8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6544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5A0A3-A168-4BED-82E1-803CFD8159EB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60015-F781-4B9D-A00B-AB83E14FA8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1402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5A0A3-A168-4BED-82E1-803CFD8159EB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60015-F781-4B9D-A00B-AB83E14FA8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31901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75A0A3-A168-4BED-82E1-803CFD8159EB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660015-F781-4B9D-A00B-AB83E14FA8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9640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4EC7B6C-94B2-47A3-8E65-26F8218731B1}"/>
              </a:ext>
            </a:extLst>
          </p:cNvPr>
          <p:cNvSpPr txBox="1"/>
          <p:nvPr/>
        </p:nvSpPr>
        <p:spPr>
          <a:xfrm>
            <a:off x="203200" y="723900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09DDA73-66A1-0F7F-E2AA-915BEA7F17AD}"/>
              </a:ext>
            </a:extLst>
          </p:cNvPr>
          <p:cNvSpPr txBox="1"/>
          <p:nvPr/>
        </p:nvSpPr>
        <p:spPr>
          <a:xfrm>
            <a:off x="325120" y="6210972"/>
            <a:ext cx="641705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ure S1. 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oomassie Brilliant Blue-stained SDS-PAGE for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each antigen. Results are shown for the reducing (left-hand side) and non-reducing (right-hand side) conditions. F1 and F2 were separated by reduction.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B84BA47B-6EAE-FD62-FF59-8FA810B15111}"/>
              </a:ext>
            </a:extLst>
          </p:cNvPr>
          <p:cNvGrpSpPr/>
          <p:nvPr/>
        </p:nvGrpSpPr>
        <p:grpSpPr>
          <a:xfrm>
            <a:off x="1144483" y="1512009"/>
            <a:ext cx="4426556" cy="4173261"/>
            <a:chOff x="1267108" y="1473787"/>
            <a:chExt cx="3825536" cy="3715015"/>
          </a:xfrm>
        </p:grpSpPr>
        <p:pic>
          <p:nvPicPr>
            <p:cNvPr id="3" name="図 2" descr="パソコンの画面&#10;&#10;中程度の精度で自動的に生成された説明">
              <a:extLst>
                <a:ext uri="{FF2B5EF4-FFF2-40B4-BE49-F238E27FC236}">
                  <a16:creationId xmlns:a16="http://schemas.microsoft.com/office/drawing/2014/main" id="{01FF1CA1-54F9-5A40-E850-653118D572E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557" t="15609" r="18964" b="15121"/>
            <a:stretch/>
          </p:blipFill>
          <p:spPr>
            <a:xfrm>
              <a:off x="1956753" y="2140727"/>
              <a:ext cx="2878483" cy="2637647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4695D633-5ED0-0669-CD47-805E1A7AA2DB}"/>
                </a:ext>
              </a:extLst>
            </p:cNvPr>
            <p:cNvSpPr txBox="1"/>
            <p:nvPr/>
          </p:nvSpPr>
          <p:spPr>
            <a:xfrm rot="16200000">
              <a:off x="1818295" y="1660348"/>
              <a:ext cx="637292" cy="2659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Marker</a:t>
              </a:r>
              <a:endParaRPr kumimoji="1" lang="ja-JP" altLang="en-US" sz="1400" dirty="0"/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2E77CF94-36E2-EF98-5653-9204E55D8155}"/>
                </a:ext>
              </a:extLst>
            </p:cNvPr>
            <p:cNvSpPr txBox="1"/>
            <p:nvPr/>
          </p:nvSpPr>
          <p:spPr>
            <a:xfrm rot="16200000">
              <a:off x="2184603" y="1735593"/>
              <a:ext cx="501900" cy="2659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Pre-F</a:t>
              </a:r>
              <a:endParaRPr kumimoji="1" lang="ja-JP" altLang="en-US" sz="1400" dirty="0"/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D3A306B7-29E2-BA03-2160-C520C89B49DB}"/>
                </a:ext>
              </a:extLst>
            </p:cNvPr>
            <p:cNvSpPr txBox="1"/>
            <p:nvPr/>
          </p:nvSpPr>
          <p:spPr>
            <a:xfrm rot="16200000">
              <a:off x="2451823" y="1698532"/>
              <a:ext cx="564687" cy="2659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Post-F</a:t>
              </a:r>
              <a:endParaRPr kumimoji="1" lang="ja-JP" altLang="en-US" sz="1400" dirty="0"/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CF89E252-F060-606F-BA05-86892C4D989D}"/>
                </a:ext>
              </a:extLst>
            </p:cNvPr>
            <p:cNvSpPr txBox="1"/>
            <p:nvPr/>
          </p:nvSpPr>
          <p:spPr>
            <a:xfrm rot="16200000">
              <a:off x="2713706" y="1659867"/>
              <a:ext cx="638148" cy="2659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KD-409</a:t>
              </a:r>
              <a:endParaRPr kumimoji="1" lang="ja-JP" altLang="en-US" sz="1400" dirty="0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FD6D6073-0B53-3962-ACC9-988C644395D5}"/>
                </a:ext>
              </a:extLst>
            </p:cNvPr>
            <p:cNvSpPr txBox="1"/>
            <p:nvPr/>
          </p:nvSpPr>
          <p:spPr>
            <a:xfrm rot="16200000">
              <a:off x="3455533" y="1660348"/>
              <a:ext cx="637292" cy="2659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Marker</a:t>
              </a:r>
              <a:endParaRPr kumimoji="1" lang="ja-JP" altLang="en-US" sz="1400" dirty="0"/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E7E1AE95-F8AF-1B06-7F1C-20C35A1D2577}"/>
                </a:ext>
              </a:extLst>
            </p:cNvPr>
            <p:cNvSpPr txBox="1"/>
            <p:nvPr/>
          </p:nvSpPr>
          <p:spPr>
            <a:xfrm rot="16200000">
              <a:off x="3791824" y="1735593"/>
              <a:ext cx="501900" cy="2659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Pre-F</a:t>
              </a:r>
              <a:endParaRPr kumimoji="1" lang="ja-JP" altLang="en-US" sz="1400" dirty="0"/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2E9D69A7-CBCD-EF3E-26EE-68A6B3CC282E}"/>
                </a:ext>
              </a:extLst>
            </p:cNvPr>
            <p:cNvSpPr txBox="1"/>
            <p:nvPr/>
          </p:nvSpPr>
          <p:spPr>
            <a:xfrm rot="16200000">
              <a:off x="4029026" y="1698532"/>
              <a:ext cx="564687" cy="2659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Post-F</a:t>
              </a:r>
              <a:endParaRPr kumimoji="1" lang="ja-JP" altLang="en-US" sz="1400" dirty="0"/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495C060B-6655-92EF-704D-9EE085329300}"/>
                </a:ext>
              </a:extLst>
            </p:cNvPr>
            <p:cNvSpPr txBox="1"/>
            <p:nvPr/>
          </p:nvSpPr>
          <p:spPr>
            <a:xfrm rot="16200000">
              <a:off x="4260890" y="1659867"/>
              <a:ext cx="638148" cy="2659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KD-409</a:t>
              </a:r>
              <a:endParaRPr kumimoji="1" lang="ja-JP" altLang="en-US" sz="1400" dirty="0"/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D6D29D7D-372C-C4E6-9D5A-5236A31AF754}"/>
                </a:ext>
              </a:extLst>
            </p:cNvPr>
            <p:cNvSpPr txBox="1"/>
            <p:nvPr/>
          </p:nvSpPr>
          <p:spPr>
            <a:xfrm>
              <a:off x="2065646" y="4883414"/>
              <a:ext cx="1366676" cy="3013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600" b="1" dirty="0"/>
                <a:t>Reduced</a:t>
              </a:r>
              <a:endParaRPr kumimoji="1" lang="ja-JP" altLang="en-US" sz="1600" b="1" dirty="0"/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45E91F9C-3785-FFFE-87C2-F936D5EAD624}"/>
                </a:ext>
              </a:extLst>
            </p:cNvPr>
            <p:cNvSpPr txBox="1"/>
            <p:nvPr/>
          </p:nvSpPr>
          <p:spPr>
            <a:xfrm>
              <a:off x="3553333" y="4887423"/>
              <a:ext cx="1539311" cy="3013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600" b="1" dirty="0"/>
                <a:t>Non-reduced</a:t>
              </a:r>
              <a:endParaRPr kumimoji="1" lang="ja-JP" altLang="en-US" sz="1600" b="1" dirty="0"/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4618A17D-F518-694B-17B2-A9A08BAA1F22}"/>
                </a:ext>
              </a:extLst>
            </p:cNvPr>
            <p:cNvSpPr txBox="1"/>
            <p:nvPr/>
          </p:nvSpPr>
          <p:spPr>
            <a:xfrm>
              <a:off x="1267108" y="1771395"/>
              <a:ext cx="479610" cy="328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 err="1"/>
                <a:t>kDa</a:t>
              </a:r>
              <a:endParaRPr kumimoji="1" lang="ja-JP" altLang="en-US" b="1" dirty="0"/>
            </a:p>
          </p:txBody>
        </p:sp>
        <p:cxnSp>
          <p:nvCxnSpPr>
            <p:cNvPr id="22" name="直線コネクタ 21">
              <a:extLst>
                <a:ext uri="{FF2B5EF4-FFF2-40B4-BE49-F238E27FC236}">
                  <a16:creationId xmlns:a16="http://schemas.microsoft.com/office/drawing/2014/main" id="{22AE7A6A-DC47-86BF-F112-874A39A4D04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25877" y="2787650"/>
              <a:ext cx="1968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8EE72ACD-ADD8-4352-ECDE-9E489785BA6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25877" y="2895600"/>
              <a:ext cx="1968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線コネクタ 23">
              <a:extLst>
                <a:ext uri="{FF2B5EF4-FFF2-40B4-BE49-F238E27FC236}">
                  <a16:creationId xmlns:a16="http://schemas.microsoft.com/office/drawing/2014/main" id="{2EC08F84-C6E1-1A0B-656B-8016232901E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25877" y="3149600"/>
              <a:ext cx="1968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id="{59FC30CB-A2A3-C2DF-8502-9EE36E2ED44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25877" y="3390900"/>
              <a:ext cx="1968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253D46C4-AADC-6B45-ED4A-C0325E15AB8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25877" y="3708400"/>
              <a:ext cx="1968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6C4C0D2A-DCAD-FFDF-9CCA-D4FFB6F382E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25877" y="3994150"/>
              <a:ext cx="1968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CB83A1CC-9E42-FB1D-8866-CC83C04CD2B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25877" y="4286250"/>
              <a:ext cx="1968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線コネクタ 28">
              <a:extLst>
                <a:ext uri="{FF2B5EF4-FFF2-40B4-BE49-F238E27FC236}">
                  <a16:creationId xmlns:a16="http://schemas.microsoft.com/office/drawing/2014/main" id="{EEEBAE0E-42B2-5CD7-DB46-13BB5DC4CF5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25877" y="4502150"/>
              <a:ext cx="1968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C073B2BB-E409-BFAB-B0C9-6EE34AAD1AB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25877" y="4724400"/>
              <a:ext cx="1968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CB63C134-034B-666F-A8C1-21450430C5DD}"/>
                </a:ext>
              </a:extLst>
            </p:cNvPr>
            <p:cNvSpPr txBox="1"/>
            <p:nvPr/>
          </p:nvSpPr>
          <p:spPr>
            <a:xfrm>
              <a:off x="1381521" y="3260095"/>
              <a:ext cx="284274" cy="2328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b="1" dirty="0"/>
                <a:t>70</a:t>
              </a:r>
              <a:endParaRPr kumimoji="1" lang="ja-JP" altLang="en-US" sz="1100" b="1" dirty="0"/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8863CA1F-91E1-7073-F800-EF4E6C1B2C12}"/>
                </a:ext>
              </a:extLst>
            </p:cNvPr>
            <p:cNvSpPr txBox="1"/>
            <p:nvPr/>
          </p:nvSpPr>
          <p:spPr>
            <a:xfrm>
              <a:off x="1345453" y="2635008"/>
              <a:ext cx="346616" cy="2328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b="1" dirty="0"/>
                <a:t>180</a:t>
              </a:r>
              <a:endParaRPr kumimoji="1" lang="ja-JP" altLang="en-US" sz="1100" b="1" dirty="0"/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E0BD3AEA-C6A6-83EF-26FE-D5CCF447484A}"/>
                </a:ext>
              </a:extLst>
            </p:cNvPr>
            <p:cNvSpPr txBox="1"/>
            <p:nvPr/>
          </p:nvSpPr>
          <p:spPr>
            <a:xfrm>
              <a:off x="1345453" y="2768358"/>
              <a:ext cx="346616" cy="2328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b="1" dirty="0"/>
                <a:t>130</a:t>
              </a:r>
              <a:endParaRPr kumimoji="1" lang="ja-JP" altLang="en-US" sz="1100" b="1" dirty="0"/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99301767-74E9-6DDE-082F-795E3E2F1E5E}"/>
                </a:ext>
              </a:extLst>
            </p:cNvPr>
            <p:cNvSpPr txBox="1"/>
            <p:nvPr/>
          </p:nvSpPr>
          <p:spPr>
            <a:xfrm>
              <a:off x="1345453" y="3009657"/>
              <a:ext cx="346616" cy="2328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b="1" dirty="0"/>
                <a:t>100</a:t>
              </a:r>
              <a:endParaRPr kumimoji="1" lang="ja-JP" altLang="en-US" sz="1100" b="1" dirty="0"/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F970068B-1845-4223-24A7-C190FD34C5E8}"/>
                </a:ext>
              </a:extLst>
            </p:cNvPr>
            <p:cNvSpPr txBox="1"/>
            <p:nvPr/>
          </p:nvSpPr>
          <p:spPr>
            <a:xfrm>
              <a:off x="1381521" y="3597678"/>
              <a:ext cx="284274" cy="2328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b="1" dirty="0"/>
                <a:t>55</a:t>
              </a:r>
              <a:endParaRPr kumimoji="1" lang="ja-JP" altLang="en-US" sz="1100" b="1" dirty="0"/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C4F4AD75-02DE-248F-10AE-10BF4209742E}"/>
                </a:ext>
              </a:extLst>
            </p:cNvPr>
            <p:cNvSpPr txBox="1"/>
            <p:nvPr/>
          </p:nvSpPr>
          <p:spPr>
            <a:xfrm>
              <a:off x="1381521" y="3854326"/>
              <a:ext cx="284274" cy="2328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b="1" dirty="0"/>
                <a:t>40</a:t>
              </a:r>
              <a:endParaRPr kumimoji="1" lang="ja-JP" altLang="en-US" sz="1100" b="1" dirty="0"/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932B48DF-3CAA-3C4A-5BED-B6654F43C4BA}"/>
                </a:ext>
              </a:extLst>
            </p:cNvPr>
            <p:cNvSpPr txBox="1"/>
            <p:nvPr/>
          </p:nvSpPr>
          <p:spPr>
            <a:xfrm>
              <a:off x="1381521" y="4140197"/>
              <a:ext cx="284274" cy="2328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b="1" dirty="0"/>
                <a:t>35</a:t>
              </a:r>
              <a:endParaRPr kumimoji="1" lang="ja-JP" altLang="en-US" sz="1100" b="1" dirty="0"/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97EA0ADA-F73A-CC62-7A6B-BFF12F0BB3DC}"/>
                </a:ext>
              </a:extLst>
            </p:cNvPr>
            <p:cNvSpPr txBox="1"/>
            <p:nvPr/>
          </p:nvSpPr>
          <p:spPr>
            <a:xfrm>
              <a:off x="1381521" y="4366374"/>
              <a:ext cx="284274" cy="2328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b="1" dirty="0"/>
                <a:t>25</a:t>
              </a:r>
              <a:endParaRPr kumimoji="1" lang="ja-JP" altLang="en-US" sz="1100" b="1" dirty="0"/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717E28AC-0F2D-C2F7-7D23-4BA283254638}"/>
                </a:ext>
              </a:extLst>
            </p:cNvPr>
            <p:cNvSpPr txBox="1"/>
            <p:nvPr/>
          </p:nvSpPr>
          <p:spPr>
            <a:xfrm>
              <a:off x="1381521" y="4582273"/>
              <a:ext cx="284274" cy="2328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b="1" dirty="0"/>
                <a:t>15</a:t>
              </a:r>
              <a:endParaRPr kumimoji="1" lang="ja-JP" altLang="en-US" sz="1100" b="1" dirty="0"/>
            </a:p>
          </p:txBody>
        </p: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CF8610E8-A453-4A34-3058-31918815214C}"/>
                </a:ext>
              </a:extLst>
            </p:cNvPr>
            <p:cNvCxnSpPr>
              <a:cxnSpLocks/>
            </p:cNvCxnSpPr>
            <p:nvPr/>
          </p:nvCxnSpPr>
          <p:spPr>
            <a:xfrm>
              <a:off x="2162175" y="4843883"/>
              <a:ext cx="1024493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id="{FF555D39-462B-BA84-4820-C3687CDAC13D}"/>
                </a:ext>
              </a:extLst>
            </p:cNvPr>
            <p:cNvCxnSpPr>
              <a:cxnSpLocks/>
            </p:cNvCxnSpPr>
            <p:nvPr/>
          </p:nvCxnSpPr>
          <p:spPr>
            <a:xfrm>
              <a:off x="3810743" y="4843883"/>
              <a:ext cx="1024493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66936EC-2407-26F8-400A-8F981E5BA034}"/>
              </a:ext>
            </a:extLst>
          </p:cNvPr>
          <p:cNvSpPr txBox="1"/>
          <p:nvPr/>
        </p:nvSpPr>
        <p:spPr>
          <a:xfrm>
            <a:off x="5492062" y="3579832"/>
            <a:ext cx="630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F1 + F2</a:t>
            </a:r>
            <a:endParaRPr kumimoji="1" lang="ja-JP" altLang="en-US" sz="1200" dirty="0"/>
          </a:p>
        </p:txBody>
      </p:sp>
      <p:sp>
        <p:nvSpPr>
          <p:cNvPr id="5" name="右中かっこ 4">
            <a:extLst>
              <a:ext uri="{FF2B5EF4-FFF2-40B4-BE49-F238E27FC236}">
                <a16:creationId xmlns:a16="http://schemas.microsoft.com/office/drawing/2014/main" id="{BCCFE6FB-5BC8-0A28-327C-4A90F10A7F22}"/>
              </a:ext>
            </a:extLst>
          </p:cNvPr>
          <p:cNvSpPr/>
          <p:nvPr/>
        </p:nvSpPr>
        <p:spPr>
          <a:xfrm>
            <a:off x="5341520" y="3521578"/>
            <a:ext cx="174926" cy="38031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右中かっこ 17">
            <a:extLst>
              <a:ext uri="{FF2B5EF4-FFF2-40B4-BE49-F238E27FC236}">
                <a16:creationId xmlns:a16="http://schemas.microsoft.com/office/drawing/2014/main" id="{7DFBE051-DE7F-90BB-A207-EB50C4DCB35C}"/>
              </a:ext>
            </a:extLst>
          </p:cNvPr>
          <p:cNvSpPr/>
          <p:nvPr/>
        </p:nvSpPr>
        <p:spPr>
          <a:xfrm>
            <a:off x="3353728" y="3818658"/>
            <a:ext cx="181951" cy="367529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64B66BA9-9D50-68CF-7A41-3DB6951827B1}"/>
              </a:ext>
            </a:extLst>
          </p:cNvPr>
          <p:cNvSpPr txBox="1"/>
          <p:nvPr/>
        </p:nvSpPr>
        <p:spPr>
          <a:xfrm>
            <a:off x="3523487" y="3867086"/>
            <a:ext cx="333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F1</a:t>
            </a:r>
            <a:endParaRPr kumimoji="1" lang="ja-JP" altLang="en-US" sz="1200" dirty="0"/>
          </a:p>
        </p:txBody>
      </p:sp>
      <p:cxnSp>
        <p:nvCxnSpPr>
          <p:cNvPr id="43" name="直線矢印コネクタ 42">
            <a:extLst>
              <a:ext uri="{FF2B5EF4-FFF2-40B4-BE49-F238E27FC236}">
                <a16:creationId xmlns:a16="http://schemas.microsoft.com/office/drawing/2014/main" id="{3909E2A6-A037-745C-6BB4-06AD25DB937C}"/>
              </a:ext>
            </a:extLst>
          </p:cNvPr>
          <p:cNvCxnSpPr/>
          <p:nvPr/>
        </p:nvCxnSpPr>
        <p:spPr>
          <a:xfrm>
            <a:off x="3365620" y="5055276"/>
            <a:ext cx="16802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BBB8F10B-59A2-9922-4268-FC0C5EC3B273}"/>
              </a:ext>
            </a:extLst>
          </p:cNvPr>
          <p:cNvSpPr txBox="1"/>
          <p:nvPr/>
        </p:nvSpPr>
        <p:spPr>
          <a:xfrm>
            <a:off x="3522620" y="4936425"/>
            <a:ext cx="333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F2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8461103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4EC7B6C-94B2-47A3-8E65-26F8218731B1}"/>
              </a:ext>
            </a:extLst>
          </p:cNvPr>
          <p:cNvSpPr txBox="1"/>
          <p:nvPr/>
        </p:nvSpPr>
        <p:spPr>
          <a:xfrm>
            <a:off x="203200" y="723900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EC2B094B-629E-712E-0187-8D033427B25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1727162"/>
              </p:ext>
            </p:extLst>
          </p:nvPr>
        </p:nvGraphicFramePr>
        <p:xfrm>
          <a:off x="220472" y="1219554"/>
          <a:ext cx="6417056" cy="2755038"/>
        </p:xfrm>
        <a:graphic>
          <a:graphicData uri="http://schemas.openxmlformats.org/drawingml/2006/table">
            <a:tbl>
              <a:tblPr/>
              <a:tblGrid>
                <a:gridCol w="486424">
                  <a:extLst>
                    <a:ext uri="{9D8B030D-6E8A-4147-A177-3AD203B41FA5}">
                      <a16:colId xmlns:a16="http://schemas.microsoft.com/office/drawing/2014/main" val="2456900664"/>
                    </a:ext>
                  </a:extLst>
                </a:gridCol>
                <a:gridCol w="907368">
                  <a:extLst>
                    <a:ext uri="{9D8B030D-6E8A-4147-A177-3AD203B41FA5}">
                      <a16:colId xmlns:a16="http://schemas.microsoft.com/office/drawing/2014/main" val="1715391698"/>
                    </a:ext>
                  </a:extLst>
                </a:gridCol>
                <a:gridCol w="907368">
                  <a:extLst>
                    <a:ext uri="{9D8B030D-6E8A-4147-A177-3AD203B41FA5}">
                      <a16:colId xmlns:a16="http://schemas.microsoft.com/office/drawing/2014/main" val="4158740243"/>
                    </a:ext>
                  </a:extLst>
                </a:gridCol>
                <a:gridCol w="907368">
                  <a:extLst>
                    <a:ext uri="{9D8B030D-6E8A-4147-A177-3AD203B41FA5}">
                      <a16:colId xmlns:a16="http://schemas.microsoft.com/office/drawing/2014/main" val="3529692141"/>
                    </a:ext>
                  </a:extLst>
                </a:gridCol>
                <a:gridCol w="907368">
                  <a:extLst>
                    <a:ext uri="{9D8B030D-6E8A-4147-A177-3AD203B41FA5}">
                      <a16:colId xmlns:a16="http://schemas.microsoft.com/office/drawing/2014/main" val="285519448"/>
                    </a:ext>
                  </a:extLst>
                </a:gridCol>
                <a:gridCol w="907368">
                  <a:extLst>
                    <a:ext uri="{9D8B030D-6E8A-4147-A177-3AD203B41FA5}">
                      <a16:colId xmlns:a16="http://schemas.microsoft.com/office/drawing/2014/main" val="3516119785"/>
                    </a:ext>
                  </a:extLst>
                </a:gridCol>
                <a:gridCol w="907368">
                  <a:extLst>
                    <a:ext uri="{9D8B030D-6E8A-4147-A177-3AD203B41FA5}">
                      <a16:colId xmlns:a16="http://schemas.microsoft.com/office/drawing/2014/main" val="256667517"/>
                    </a:ext>
                  </a:extLst>
                </a:gridCol>
                <a:gridCol w="486424">
                  <a:extLst>
                    <a:ext uri="{9D8B030D-6E8A-4147-A177-3AD203B41FA5}">
                      <a16:colId xmlns:a16="http://schemas.microsoft.com/office/drawing/2014/main" val="2186201504"/>
                    </a:ext>
                  </a:extLst>
                </a:gridCol>
              </a:tblGrid>
              <a:tr h="19317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8921699"/>
                  </a:ext>
                </a:extLst>
              </a:tr>
              <a:tr h="370692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rotein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Reactivity (anti-RSV F antibodies, absorbance)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17980474"/>
                  </a:ext>
                </a:extLst>
              </a:tr>
              <a:tr h="370692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ite</a:t>
                      </a:r>
                      <a:r>
                        <a:rPr lang="el-GR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Φ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ite I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ite II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ite III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ite IV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21390211"/>
                  </a:ext>
                </a:extLst>
              </a:tr>
              <a:tr h="511661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re-F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.579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97B7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649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0F3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.038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AA1A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.769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BB5B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.822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53003473"/>
                  </a:ext>
                </a:extLst>
              </a:tr>
              <a:tr h="511661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ost-F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53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763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.214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C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551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EC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.412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78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6012014"/>
                  </a:ext>
                </a:extLst>
              </a:tr>
              <a:tr h="511661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KD-409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734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B3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313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EDC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816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9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189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D3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004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FC6E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3448545"/>
                  </a:ext>
                </a:extLst>
              </a:tr>
              <a:tr h="28549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311" marR="4311" marT="43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3894155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09DDA73-66A1-0F7F-E2AA-915BEA7F17AD}"/>
              </a:ext>
            </a:extLst>
          </p:cNvPr>
          <p:cNvSpPr txBox="1"/>
          <p:nvPr/>
        </p:nvSpPr>
        <p:spPr>
          <a:xfrm>
            <a:off x="325120" y="4352835"/>
            <a:ext cx="641705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ure S2. Reactivity of each antigen with anti-respiratory syncytial virus (RSV) F antibodies determined by absorbance. 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ite φ, D25; 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ite I, 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131-2a; 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ite II, </a:t>
            </a:r>
            <a:r>
              <a:rPr lang="en-US" altLang="ja-JP" sz="14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alivizumab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; 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ite III, 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PE8; site IV, 101F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79911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4EC7B6C-94B2-47A3-8E65-26F8218731B1}"/>
              </a:ext>
            </a:extLst>
          </p:cNvPr>
          <p:cNvSpPr txBox="1"/>
          <p:nvPr/>
        </p:nvSpPr>
        <p:spPr>
          <a:xfrm>
            <a:off x="203200" y="723900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 descr="夜の街のイラスト&#10;&#10;自動的に生成された説明">
            <a:extLst>
              <a:ext uri="{FF2B5EF4-FFF2-40B4-BE49-F238E27FC236}">
                <a16:creationId xmlns:a16="http://schemas.microsoft.com/office/drawing/2014/main" id="{84E4FA7B-36A5-1C70-87FB-AD079CB781D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844" y="1303020"/>
            <a:ext cx="6306312" cy="5087112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DCE2D36-B5C4-0C05-6693-038DC14426F1}"/>
              </a:ext>
            </a:extLst>
          </p:cNvPr>
          <p:cNvSpPr txBox="1"/>
          <p:nvPr/>
        </p:nvSpPr>
        <p:spPr>
          <a:xfrm>
            <a:off x="203199" y="7071360"/>
            <a:ext cx="6378957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ure S3.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Dose–response 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valuation of protection against infection. Lung viral loads/virus copy numbers were measured using quantitative polymerase chain reaction (0.005–15 µg/dose antigen without </a:t>
            </a:r>
            <a:r>
              <a:rPr lang="en-US" altLang="ja-JP" sz="14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dju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Phos; n = 16). Error bars indicate the 95% confidence interval. LOD, limit of detection; RSV, respiratory syncytial virus; BALF, bronchoalveolar lavage fluid; post-F, post-fusion F.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57362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4EC7B6C-94B2-47A3-8E65-26F8218731B1}"/>
              </a:ext>
            </a:extLst>
          </p:cNvPr>
          <p:cNvSpPr txBox="1"/>
          <p:nvPr/>
        </p:nvSpPr>
        <p:spPr>
          <a:xfrm>
            <a:off x="203200" y="723900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ig. S4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DCE2D36-B5C4-0C05-6693-038DC14426F1}"/>
              </a:ext>
            </a:extLst>
          </p:cNvPr>
          <p:cNvSpPr txBox="1"/>
          <p:nvPr/>
        </p:nvSpPr>
        <p:spPr>
          <a:xfrm>
            <a:off x="203199" y="7071360"/>
            <a:ext cx="6378957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ure S4.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Anti-RSV F antibody titers 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of 2wk pups born from mothers inoculated twice with KD-409 and </a:t>
            </a:r>
            <a:r>
              <a:rPr lang="en-US" altLang="ja-JP" sz="14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dju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Phos by intramuscular administration. Anti-RSV F antibody titers w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re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measured by ELISA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(n = 5-11).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Refer to "2.7. Anti-RSV F Antibody Titer" for the specific method. Error bars indicate the 95% confidence interval.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2D84842E-E7F4-98EF-182A-5CDF2EB33B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9514" y="1297467"/>
            <a:ext cx="5406325" cy="55696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89289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3bae39db-7cce-4674-ade5-53a66d9e11df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9DC440B8B881DD4FA67AFAFDA2D63AB7" ma:contentTypeVersion="14" ma:contentTypeDescription="新しいドキュメントを作成します。" ma:contentTypeScope="" ma:versionID="8036f0bb1b3a44a38779c128efad8716">
  <xsd:schema xmlns:xsd="http://www.w3.org/2001/XMLSchema" xmlns:xs="http://www.w3.org/2001/XMLSchema" xmlns:p="http://schemas.microsoft.com/office/2006/metadata/properties" xmlns:ns3="3bae39db-7cce-4674-ade5-53a66d9e11df" xmlns:ns4="605d9844-3c44-4249-b0a6-68080c6c7dda" targetNamespace="http://schemas.microsoft.com/office/2006/metadata/properties" ma:root="true" ma:fieldsID="b334e38b1bd74630972431f1a9436ad4" ns3:_="" ns4:_="">
    <xsd:import namespace="3bae39db-7cce-4674-ade5-53a66d9e11df"/>
    <xsd:import namespace="605d9844-3c44-4249-b0a6-68080c6c7dda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DateTaken" minOccurs="0"/>
                <xsd:element ref="ns3:MediaLengthInSecond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_activity" minOccurs="0"/>
                <xsd:element ref="ns3:MediaServiceLocation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bae39db-7cce-4674-ade5-53a66d9e11d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4" nillable="true" ma:displayName="Length (seconds)" ma:internalName="MediaLengthInSeconds" ma:readOnly="true">
      <xsd:simpleType>
        <xsd:restriction base="dms:Unknown"/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_activity" ma:index="19" nillable="true" ma:displayName="_activity" ma:hidden="true" ma:internalName="_activity">
      <xsd:simpleType>
        <xsd:restriction base="dms:Note"/>
      </xsd:simpleType>
    </xsd:element>
    <xsd:element name="MediaServiceLocation" ma:index="20" nillable="true" ma:displayName="Location" ma:indexed="true" ma:internalName="MediaServiceLocation" ma:readOnly="true">
      <xsd:simpleType>
        <xsd:restriction base="dms:Text"/>
      </xsd:simpleType>
    </xsd:element>
    <xsd:element name="MediaServiceObjectDetectorVersions" ma:index="2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05d9844-3c44-4249-b0a6-68080c6c7dda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共有相手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共有相手の詳細情報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共有のヒントのハッシュ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9748BFA8-7DD6-4728-B6C5-DE7D9FE09A2C}">
  <ds:schemaRefs>
    <ds:schemaRef ds:uri="http://schemas.microsoft.com/office/2006/documentManagement/types"/>
    <ds:schemaRef ds:uri="http://schemas.openxmlformats.org/package/2006/metadata/core-properties"/>
    <ds:schemaRef ds:uri="http://purl.org/dc/terms/"/>
    <ds:schemaRef ds:uri="http://purl.org/dc/dcmitype/"/>
    <ds:schemaRef ds:uri="http://purl.org/dc/elements/1.1/"/>
    <ds:schemaRef ds:uri="http://schemas.microsoft.com/office/infopath/2007/PartnerControls"/>
    <ds:schemaRef ds:uri="http://schemas.microsoft.com/office/2006/metadata/properties"/>
    <ds:schemaRef ds:uri="605d9844-3c44-4249-b0a6-68080c6c7dda"/>
    <ds:schemaRef ds:uri="3bae39db-7cce-4674-ade5-53a66d9e11df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94315618-E003-47F7-88AF-A1978786DC0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bae39db-7cce-4674-ade5-53a66d9e11df"/>
    <ds:schemaRef ds:uri="605d9844-3c44-4249-b0a6-68080c6c7dd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E5C34A97-F4E9-43B7-B37E-7DBFAB078214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57</TotalTime>
  <Words>312</Words>
  <Application>Microsoft Office PowerPoint</Application>
  <PresentationFormat>A4 210 x 297 mm</PresentationFormat>
  <Paragraphs>82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上　亮（研究・第１）</dc:creator>
  <cp:lastModifiedBy>山上　亮（研究・第１）</cp:lastModifiedBy>
  <cp:revision>75</cp:revision>
  <cp:lastPrinted>2024-05-28T01:34:17Z</cp:lastPrinted>
  <dcterms:created xsi:type="dcterms:W3CDTF">2021-09-08T00:10:24Z</dcterms:created>
  <dcterms:modified xsi:type="dcterms:W3CDTF">2024-07-03T03:45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DC440B8B881DD4FA67AFAFDA2D63AB7</vt:lpwstr>
  </property>
</Properties>
</file>